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83D50-C4D9-4221-9AE2-09EEA7C788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2C97F2-5AB6-4D8F-841D-6AB66E415F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0C192-B120-4CD4-895A-DD7E8D4A9F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D329B-E70A-4552-BF61-D7CAEAB3C3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92592-1DD9-4E89-A08B-B40E6C500A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9E48B-2CA9-4AFF-9FD8-6649042D2B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9E1DD-83C3-4730-9138-04CFFDDC8B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0C40E-00CC-490C-AFB9-1EE9FB660C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73B8E-D22D-4220-8B1D-271E58BCAB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2D666-052E-4D3D-A2D8-DD52D9B645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DB2D1-6C5D-428A-9B58-D7FC22295E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EE633-7355-4E27-91ED-AAA26205C2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9CC44C-26CF-467E-99DA-AD46DD4D8781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77920" y="15778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65120" y="31622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57200" y="6634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514440" y="31780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1154160" y="27702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853920" y="32623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579600" y="873000"/>
            <a:ext cx="5143320" cy="338148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838080" y="4800600"/>
            <a:ext cx="5273640" cy="85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6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resentation of the cumulative alignment score of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grA to LgrF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 amoebophila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Since this method aligned sequences of equal lengths, the 2-residue repetition (EV) of LRR</a:t>
            </a:r>
            <a:r>
              <a:rPr b="0" lang="en-US" sz="1200" spc="-1" strike="noStrike" baseline="-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Lgr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hown on Figure 3 was ignored.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22:55Z</dcterms:created>
  <dc:creator>Gilbert Greub</dc:creator>
  <dc:description/>
  <dc:language>en-US</dc:language>
  <cp:lastModifiedBy>CA Roten</cp:lastModifiedBy>
  <dcterms:modified xsi:type="dcterms:W3CDTF">2007-11-14T10:54:12Z</dcterms:modified>
  <cp:revision>12</cp:revision>
  <dc:subject/>
  <dc:title>Présentation PowerPoint</dc:title>
</cp:coreProperties>
</file>